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9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83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548518-718C-E767-4968-7EC9BD62067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D00799E-63B6-A4F1-24B8-52770EFE44A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A274B4-3EB3-2B93-9BDE-C516E20B39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5692E0-1D2F-4872-BC04-7631094B052F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AF0C68-82E7-D5BB-93B0-86DC84EDD4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57F23D-CA69-4C1D-3ECF-80B7ED6724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F827-A262-4CCF-AB2D-3AA8A451D4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03044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D06A8A-4857-4F9D-072B-B4046660F8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13C2C4A-3B55-6E99-48F0-B12807BAFE9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A99AD9-595A-6F7A-8863-8F84CB5B1D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5692E0-1D2F-4872-BC04-7631094B052F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737E477-C43B-D81D-2BB9-65376883B6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2C0047-196B-CA5C-2A21-9784AF3818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F827-A262-4CCF-AB2D-3AA8A451D4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74656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58A1568-4ECD-85F0-F369-AE2443EF065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319FC3B-0399-412E-990D-168E205E75E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1B84186-1623-4EE4-5BA6-D46F4D245A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5692E0-1D2F-4872-BC04-7631094B052F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D048ED-79A5-1562-0BC1-E938497A9C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B41102D-FC84-C59E-4887-9FEC90D5DD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F827-A262-4CCF-AB2D-3AA8A451D4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10044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F2DD3F-D0B5-4E03-BF4A-DF57B21CCC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3D20558-ECDB-F03B-1512-987CB8A48CC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DDA0507-7BAE-AA71-8020-1D18752510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5692E0-1D2F-4872-BC04-7631094B052F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5FE015-22B4-02CD-D1DF-426BD7D6FB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35D385-A4D8-E38C-5579-D2CB9E6943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F827-A262-4CCF-AB2D-3AA8A451D4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71587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E10B42-B9E8-A1EB-3EDF-97928FE84B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0DF0A9F-7CDB-E8A1-B579-34040051F4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6592A7-AD57-213C-EDAF-403DB4FA2C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5692E0-1D2F-4872-BC04-7631094B052F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0FBE4CA-A471-439B-F4B1-D781D1AA76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BB1A7E4-C216-414B-D3E0-7FEFE48D78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F827-A262-4CCF-AB2D-3AA8A451D4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23128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0E6498-7C04-16DB-92F4-1A175D3C8C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50A09F9-9714-F006-6A2C-19441EC3182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533AE81-0B29-7108-423F-7F89433A30B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8CB808B-C817-A428-E3D7-9EB344C261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5692E0-1D2F-4872-BC04-7631094B052F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46686AE-55AB-9002-41D3-A615C8146B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385CF75-9ED5-E865-759D-9AE124A1C1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F827-A262-4CCF-AB2D-3AA8A451D4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88378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A6DCA7-DFFB-6837-1294-83E7D0CA6D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761150E-0520-9D26-7122-55859B92E35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BD8C319-75FC-032B-98CA-087D03AEBE0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BC6C215-4970-8BDD-84C0-EFF340AF9CC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66FB2DD-917B-FD24-2208-3BB19398D6A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1EBB1B6-8FE9-EDAE-3A49-923DFAC857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5692E0-1D2F-4872-BC04-7631094B052F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DEEE3B5-EA98-D6B1-46B8-C15559A949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273377D-6D20-A2FF-BCFE-836CF177F8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F827-A262-4CCF-AB2D-3AA8A451D4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01205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18B8E0-CD4E-FE78-EF40-99DAAF3F88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4336121-90FA-A259-06D7-206C3DC41E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5692E0-1D2F-4872-BC04-7631094B052F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4448C57-83E1-8D8E-42F1-AF95BE71EB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FE9B5F8-315C-5865-2385-722A7C2128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F827-A262-4CCF-AB2D-3AA8A451D4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49881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7AC7202-EB68-861E-C780-71BD05CE28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5692E0-1D2F-4872-BC04-7631094B052F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9AECB16-B093-3A5A-3C38-E33A08A3AF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51900A3-B992-7A71-1EB7-F19559DF9E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F827-A262-4CCF-AB2D-3AA8A451D4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21267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5B3A43-E22D-B55D-EDE1-5BBC82CE71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DD402C9-D261-5417-A5AE-0D8BCEB2BC4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57AD40C-B79B-4997-9589-57F2DDECB5A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7C17BBB-E5AC-FF8A-DEA8-98A957B4B2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5692E0-1D2F-4872-BC04-7631094B052F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970A20E-A0D6-05F5-4A19-AF4D809D15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80DD199-37CD-6999-6957-69995C0435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F827-A262-4CCF-AB2D-3AA8A451D4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51056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26706C-55EA-01BF-1BD2-B070C879C9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EFA39EA-192D-1DAB-4AD2-AA11033F69D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6570C1A-64D6-3D66-C467-85B36DC8711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4B32461-8F18-D5B2-99B7-6C1026D064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5692E0-1D2F-4872-BC04-7631094B052F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CB71340-AA32-7DF3-77DF-ECD2EE3FF2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6B3D701-CA4F-1501-6CC7-ED960B761F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84F827-A262-4CCF-AB2D-3AA8A451D4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45987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54F2954-65D6-E0A2-7974-F1E265DF99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ED77E51-0FDB-9EC1-366C-F901DAAC6D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708870-6FB7-6F09-5795-BB4CF53E27F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F5692E0-1D2F-4872-BC04-7631094B052F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938AAF3-5CE2-8DBB-62FC-A44BD64FEAA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CDDA74-E45B-EEBE-4130-501E7AE3F7C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A84F827-A262-4CCF-AB2D-3AA8A451D4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98226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/>
        </p:nvGraphicFramePr>
        <p:xfrm>
          <a:off x="88491" y="829274"/>
          <a:ext cx="12058281" cy="4610677"/>
        </p:xfrm>
        <a:graphic>
          <a:graphicData uri="http://schemas.openxmlformats.org/drawingml/2006/table">
            <a:tbl>
              <a:tblPr/>
              <a:tblGrid>
                <a:gridCol w="1193771">
                  <a:extLst>
                    <a:ext uri="{9D8B030D-6E8A-4147-A177-3AD203B41FA5}">
                      <a16:colId xmlns:a16="http://schemas.microsoft.com/office/drawing/2014/main" val="1301505257"/>
                    </a:ext>
                  </a:extLst>
                </a:gridCol>
                <a:gridCol w="1019504">
                  <a:extLst>
                    <a:ext uri="{9D8B030D-6E8A-4147-A177-3AD203B41FA5}">
                      <a16:colId xmlns:a16="http://schemas.microsoft.com/office/drawing/2014/main" val="108077517"/>
                    </a:ext>
                  </a:extLst>
                </a:gridCol>
                <a:gridCol w="525517">
                  <a:extLst>
                    <a:ext uri="{9D8B030D-6E8A-4147-A177-3AD203B41FA5}">
                      <a16:colId xmlns:a16="http://schemas.microsoft.com/office/drawing/2014/main" val="1498952803"/>
                    </a:ext>
                  </a:extLst>
                </a:gridCol>
                <a:gridCol w="819807">
                  <a:extLst>
                    <a:ext uri="{9D8B030D-6E8A-4147-A177-3AD203B41FA5}">
                      <a16:colId xmlns:a16="http://schemas.microsoft.com/office/drawing/2014/main" val="1157135499"/>
                    </a:ext>
                  </a:extLst>
                </a:gridCol>
                <a:gridCol w="1008993">
                  <a:extLst>
                    <a:ext uri="{9D8B030D-6E8A-4147-A177-3AD203B41FA5}">
                      <a16:colId xmlns:a16="http://schemas.microsoft.com/office/drawing/2014/main" val="3089750866"/>
                    </a:ext>
                  </a:extLst>
                </a:gridCol>
                <a:gridCol w="777719">
                  <a:extLst>
                    <a:ext uri="{9D8B030D-6E8A-4147-A177-3AD203B41FA5}">
                      <a16:colId xmlns:a16="http://schemas.microsoft.com/office/drawing/2014/main" val="3852637103"/>
                    </a:ext>
                  </a:extLst>
                </a:gridCol>
                <a:gridCol w="629779">
                  <a:extLst>
                    <a:ext uri="{9D8B030D-6E8A-4147-A177-3AD203B41FA5}">
                      <a16:colId xmlns:a16="http://schemas.microsoft.com/office/drawing/2014/main" val="2455096405"/>
                    </a:ext>
                  </a:extLst>
                </a:gridCol>
                <a:gridCol w="555072">
                  <a:extLst>
                    <a:ext uri="{9D8B030D-6E8A-4147-A177-3AD203B41FA5}">
                      <a16:colId xmlns:a16="http://schemas.microsoft.com/office/drawing/2014/main" val="2519692688"/>
                    </a:ext>
                  </a:extLst>
                </a:gridCol>
                <a:gridCol w="700432">
                  <a:extLst>
                    <a:ext uri="{9D8B030D-6E8A-4147-A177-3AD203B41FA5}">
                      <a16:colId xmlns:a16="http://schemas.microsoft.com/office/drawing/2014/main" val="2291691970"/>
                    </a:ext>
                  </a:extLst>
                </a:gridCol>
                <a:gridCol w="836943">
                  <a:extLst>
                    <a:ext uri="{9D8B030D-6E8A-4147-A177-3AD203B41FA5}">
                      <a16:colId xmlns:a16="http://schemas.microsoft.com/office/drawing/2014/main" val="3204549999"/>
                    </a:ext>
                  </a:extLst>
                </a:gridCol>
                <a:gridCol w="3990744">
                  <a:extLst>
                    <a:ext uri="{9D8B030D-6E8A-4147-A177-3AD203B41FA5}">
                      <a16:colId xmlns:a16="http://schemas.microsoft.com/office/drawing/2014/main" val="3066430848"/>
                    </a:ext>
                  </a:extLst>
                </a:gridCol>
              </a:tblGrid>
              <a:tr h="355108">
                <a:tc rowSpan="2">
                  <a:txBody>
                    <a:bodyPr/>
                    <a:lstStyle/>
                    <a:p>
                      <a:pPr algn="ctr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NTC ID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ND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gion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/Sex/Race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st</a:t>
                      </a:r>
                    </a:p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sma VL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05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st</a:t>
                      </a:r>
                      <a:r>
                        <a:rPr lang="en-US" sz="11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SF VL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05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ssue viral RNA</a:t>
                      </a:r>
                    </a:p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copies/mg)</a:t>
                      </a:r>
                    </a:p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her</a:t>
                      </a:r>
                      <a:r>
                        <a:rPr lang="en-US" sz="1100" b="1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disease</a:t>
                      </a:r>
                      <a:endParaRPr lang="en-US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45184763"/>
                  </a:ext>
                </a:extLst>
              </a:tr>
              <a:tr h="486763">
                <a:tc vMerge="1">
                  <a:txBody>
                    <a:bodyPr/>
                    <a:lstStyle/>
                    <a:p>
                      <a:pPr algn="ctr" fontAlgn="b"/>
                      <a:endParaRPr lang="en-US" sz="105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b"/>
                      <a:endParaRPr lang="en-US" sz="105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b"/>
                      <a:endParaRPr lang="en-US" sz="105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 marL="6301" marR="6301" marT="6301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b"/>
                      <a:endParaRPr lang="en-US" sz="105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L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L</a:t>
                      </a:r>
                      <a:r>
                        <a:rPr lang="en-US" sz="1100" b="1" i="0" u="none" strike="noStrike" baseline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100" b="1" i="0" u="none" strike="noStrike" baseline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te</a:t>
                      </a:r>
                      <a:r>
                        <a:rPr lang="en-US" sz="1100" b="0" i="0" u="none" strike="noStrike" baseline="3000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endParaRPr lang="en-US" sz="1100" b="0" i="0" u="none" strike="noStrike" baseline="30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L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L</a:t>
                      </a:r>
                      <a:r>
                        <a:rPr lang="en-US" sz="11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100" b="1" i="0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te</a:t>
                      </a:r>
                      <a:r>
                        <a:rPr lang="en-US" sz="1100" b="0" i="0" u="none" strike="noStrike" baseline="300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endParaRPr lang="en-US" sz="11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fontAlgn="b"/>
                      <a:endParaRPr lang="en-US" sz="105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85320185"/>
                  </a:ext>
                </a:extLst>
              </a:tr>
              <a:tr h="1576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ND case 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013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D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M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/W/B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4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month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5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month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ASTING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47562707"/>
                  </a:ext>
                </a:extLst>
              </a:tr>
              <a:tr h="1576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ND case 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00537480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D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M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/M/O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13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1 month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4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1 month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PATIC ENCEPHALOPATHY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84702466"/>
                  </a:ext>
                </a:extLst>
              </a:tr>
              <a:tr h="1576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ND case 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56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D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M &amp; GM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/M/W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1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1 month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N/A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N/A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YPTOCOCCUS (EXTRAPULMONARY) ; MAC/MAI DIS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96989215"/>
                  </a:ext>
                </a:extLst>
              </a:tr>
              <a:tr h="22256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ND case 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28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D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M &amp; GM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/F/O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000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 month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N/A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N/A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ASTING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55685347"/>
                  </a:ext>
                </a:extLst>
              </a:tr>
              <a:tr h="1576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ND case 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70*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D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M &amp; GM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2/M/B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N/A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N/A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N/A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N/A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SEPTIC MENINGITIS; HTLV - 11, HCV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73426825"/>
                  </a:ext>
                </a:extLst>
              </a:tr>
              <a:tr h="1576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ND case 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00658283^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D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M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8/M/W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590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month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9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1 month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gt;50000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24581691"/>
                  </a:ext>
                </a:extLst>
              </a:tr>
              <a:tr h="1576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ND case 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37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D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M &amp; GM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/M/W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63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month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N/A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N/A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gt;50000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ELOPATHY - POSSIBLE HIV ASSOCIATION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9377733"/>
                  </a:ext>
                </a:extLst>
              </a:tr>
              <a:tr h="1576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ND case 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52*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D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M &amp; GM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/F/O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month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N/A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N/A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PATITIS C INFECTION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82470136"/>
                  </a:ext>
                </a:extLst>
              </a:tr>
              <a:tr h="1576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ND case 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00616568^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D 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M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/M/W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979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1 month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000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1 month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gt;500000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MV end disease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3822982"/>
                  </a:ext>
                </a:extLst>
              </a:tr>
              <a:tr h="1576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ND case 1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35*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D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M &amp; GM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/M/O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8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month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N/A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N/A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P C, HEP B, POOR ADHERENCE TO ART 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34852642"/>
                  </a:ext>
                </a:extLst>
              </a:tr>
              <a:tr h="157650"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11879355"/>
                  </a:ext>
                </a:extLst>
              </a:tr>
              <a:tr h="18963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ND case 1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19*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ND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M &amp; GM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/M/O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6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month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N/A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N/A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CV; HIV ASEPTIC MENINGITI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42932246"/>
                  </a:ext>
                </a:extLst>
              </a:tr>
              <a:tr h="1576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ND case 1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00686683^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ND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M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/M/W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375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month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1 month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ltifocal 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ukoencephalo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wasting/CMV end/congestive heart failure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13198963"/>
                  </a:ext>
                </a:extLst>
              </a:tr>
              <a:tr h="1576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ND case 1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025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ND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M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/M/W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000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 month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month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gt;500000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26922203"/>
                  </a:ext>
                </a:extLst>
              </a:tr>
              <a:tr h="1576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ND case 1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143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ND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M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2/M/W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month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1 month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/A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YPTOSPORIDIUM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15552284"/>
                  </a:ext>
                </a:extLst>
              </a:tr>
              <a:tr h="1576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ND case 1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125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ND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M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/M/W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095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month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9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1 month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/A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YPTOSPORIDIUM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49765839"/>
                  </a:ext>
                </a:extLst>
              </a:tr>
              <a:tr h="1576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ND case 1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71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ND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M &amp; GM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/M/W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58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month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5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 month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ASTING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49703398"/>
                  </a:ext>
                </a:extLst>
              </a:tr>
              <a:tr h="1576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ND case 1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00626868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I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M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/M/W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1 month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5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 month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73826568"/>
                  </a:ext>
                </a:extLst>
              </a:tr>
              <a:tr h="1576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ND case 1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00547672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I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M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4/M/W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month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48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1 month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UNG CANCER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23728817"/>
                  </a:ext>
                </a:extLst>
              </a:tr>
              <a:tr h="15765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ND case 1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13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1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NI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1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WM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/M/W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000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 month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/A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/A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321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40239023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1798" y="521497"/>
            <a:ext cx="80565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2 Table . Characteristics of 19 PWH with HAND for the quantitative TMT proteomic analysis.</a:t>
            </a:r>
          </a:p>
        </p:txBody>
      </p:sp>
      <p:sp>
        <p:nvSpPr>
          <p:cNvPr id="6" name="Rectangle 5"/>
          <p:cNvSpPr/>
          <p:nvPr/>
        </p:nvSpPr>
        <p:spPr>
          <a:xfrm>
            <a:off x="0" y="5442581"/>
            <a:ext cx="11563544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1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bbreviations: WM, white matter; GM, gray matter; M, male; B, black; W, white; O, others. UD, under detectable. NA, not available. * donor with HCV co-infection. ^With CMV end disease.</a:t>
            </a:r>
            <a:r>
              <a:rPr lang="en-US" sz="1100" baseline="30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date before death.</a:t>
            </a:r>
            <a:endParaRPr lang="en-US" sz="1100" baseline="300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68058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95</Words>
  <Application>Microsoft Office PowerPoint</Application>
  <PresentationFormat>Widescreen</PresentationFormat>
  <Paragraphs>2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Tang, Yuyang</dc:creator>
  <cp:lastModifiedBy>Tang, Yuyang</cp:lastModifiedBy>
  <cp:revision>1</cp:revision>
  <dcterms:created xsi:type="dcterms:W3CDTF">2025-07-28T20:18:22Z</dcterms:created>
  <dcterms:modified xsi:type="dcterms:W3CDTF">2025-07-28T20:19:08Z</dcterms:modified>
</cp:coreProperties>
</file>